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Overall%20liver%20hospitalizations_Canada_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Monthly</a:t>
            </a:r>
            <a:r>
              <a:rPr lang="en-US" baseline="0" dirty="0"/>
              <a:t> r</a:t>
            </a:r>
            <a:r>
              <a:rPr lang="en-US" dirty="0"/>
              <a:t>ate of total liver-related hospitalizations per 1,000,000 of Canadian popula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5"/>
          <c:order val="0"/>
          <c:tx>
            <c:strRef>
              <c:f>Sheet1!$G$1</c:f>
              <c:strCache>
                <c:ptCount val="1"/>
                <c:pt idx="0">
                  <c:v>Hosp rate per 1M</c:v>
                </c:pt>
              </c:strCache>
            </c:strRef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none"/>
          </c:marker>
          <c:cat>
            <c:numRef>
              <c:f>Sheet1!$A$2:$A$169</c:f>
              <c:numCache>
                <c:formatCode>[$-409]mmmm\ d\,\ yyyy;@</c:formatCode>
                <c:ptCount val="168"/>
                <c:pt idx="0">
                  <c:v>38808</c:v>
                </c:pt>
                <c:pt idx="1">
                  <c:v>38838</c:v>
                </c:pt>
                <c:pt idx="2">
                  <c:v>38869</c:v>
                </c:pt>
                <c:pt idx="3">
                  <c:v>38899</c:v>
                </c:pt>
                <c:pt idx="4">
                  <c:v>38930</c:v>
                </c:pt>
                <c:pt idx="5">
                  <c:v>38961</c:v>
                </c:pt>
                <c:pt idx="6">
                  <c:v>38991</c:v>
                </c:pt>
                <c:pt idx="7">
                  <c:v>39022</c:v>
                </c:pt>
                <c:pt idx="8">
                  <c:v>39052</c:v>
                </c:pt>
                <c:pt idx="9">
                  <c:v>39083</c:v>
                </c:pt>
                <c:pt idx="10">
                  <c:v>39114</c:v>
                </c:pt>
                <c:pt idx="11">
                  <c:v>39142</c:v>
                </c:pt>
                <c:pt idx="12">
                  <c:v>39173</c:v>
                </c:pt>
                <c:pt idx="13">
                  <c:v>39203</c:v>
                </c:pt>
                <c:pt idx="14">
                  <c:v>39234</c:v>
                </c:pt>
                <c:pt idx="15">
                  <c:v>39264</c:v>
                </c:pt>
                <c:pt idx="16">
                  <c:v>39295</c:v>
                </c:pt>
                <c:pt idx="17">
                  <c:v>39326</c:v>
                </c:pt>
                <c:pt idx="18">
                  <c:v>39356</c:v>
                </c:pt>
                <c:pt idx="19">
                  <c:v>39387</c:v>
                </c:pt>
                <c:pt idx="20">
                  <c:v>39417</c:v>
                </c:pt>
                <c:pt idx="21">
                  <c:v>39448</c:v>
                </c:pt>
                <c:pt idx="22">
                  <c:v>39479</c:v>
                </c:pt>
                <c:pt idx="23">
                  <c:v>39508</c:v>
                </c:pt>
                <c:pt idx="24">
                  <c:v>39539</c:v>
                </c:pt>
                <c:pt idx="25">
                  <c:v>39569</c:v>
                </c:pt>
                <c:pt idx="26">
                  <c:v>39600</c:v>
                </c:pt>
                <c:pt idx="27">
                  <c:v>39630</c:v>
                </c:pt>
                <c:pt idx="28">
                  <c:v>39661</c:v>
                </c:pt>
                <c:pt idx="29">
                  <c:v>39692</c:v>
                </c:pt>
                <c:pt idx="30">
                  <c:v>39722</c:v>
                </c:pt>
                <c:pt idx="31">
                  <c:v>39753</c:v>
                </c:pt>
                <c:pt idx="32">
                  <c:v>39783</c:v>
                </c:pt>
                <c:pt idx="33">
                  <c:v>39814</c:v>
                </c:pt>
                <c:pt idx="34">
                  <c:v>39845</c:v>
                </c:pt>
                <c:pt idx="35">
                  <c:v>39873</c:v>
                </c:pt>
                <c:pt idx="36">
                  <c:v>39904</c:v>
                </c:pt>
                <c:pt idx="37">
                  <c:v>39934</c:v>
                </c:pt>
                <c:pt idx="38">
                  <c:v>39965</c:v>
                </c:pt>
                <c:pt idx="39">
                  <c:v>39995</c:v>
                </c:pt>
                <c:pt idx="40">
                  <c:v>40026</c:v>
                </c:pt>
                <c:pt idx="41">
                  <c:v>40057</c:v>
                </c:pt>
                <c:pt idx="42">
                  <c:v>40087</c:v>
                </c:pt>
                <c:pt idx="43">
                  <c:v>40118</c:v>
                </c:pt>
                <c:pt idx="44">
                  <c:v>40148</c:v>
                </c:pt>
                <c:pt idx="45">
                  <c:v>40179</c:v>
                </c:pt>
                <c:pt idx="46">
                  <c:v>40210</c:v>
                </c:pt>
                <c:pt idx="47">
                  <c:v>40238</c:v>
                </c:pt>
                <c:pt idx="48">
                  <c:v>40269</c:v>
                </c:pt>
                <c:pt idx="49">
                  <c:v>40299</c:v>
                </c:pt>
                <c:pt idx="50">
                  <c:v>40330</c:v>
                </c:pt>
                <c:pt idx="51">
                  <c:v>40360</c:v>
                </c:pt>
                <c:pt idx="52">
                  <c:v>40391</c:v>
                </c:pt>
                <c:pt idx="53">
                  <c:v>40422</c:v>
                </c:pt>
                <c:pt idx="54">
                  <c:v>40452</c:v>
                </c:pt>
                <c:pt idx="55">
                  <c:v>40483</c:v>
                </c:pt>
                <c:pt idx="56">
                  <c:v>40513</c:v>
                </c:pt>
                <c:pt idx="57">
                  <c:v>40544</c:v>
                </c:pt>
                <c:pt idx="58">
                  <c:v>40575</c:v>
                </c:pt>
                <c:pt idx="59">
                  <c:v>40603</c:v>
                </c:pt>
                <c:pt idx="60">
                  <c:v>40634</c:v>
                </c:pt>
                <c:pt idx="61">
                  <c:v>40664</c:v>
                </c:pt>
                <c:pt idx="62">
                  <c:v>40695</c:v>
                </c:pt>
                <c:pt idx="63">
                  <c:v>40725</c:v>
                </c:pt>
                <c:pt idx="64">
                  <c:v>40756</c:v>
                </c:pt>
                <c:pt idx="65">
                  <c:v>40787</c:v>
                </c:pt>
                <c:pt idx="66">
                  <c:v>40817</c:v>
                </c:pt>
                <c:pt idx="67">
                  <c:v>40848</c:v>
                </c:pt>
                <c:pt idx="68">
                  <c:v>40878</c:v>
                </c:pt>
                <c:pt idx="69">
                  <c:v>40909</c:v>
                </c:pt>
                <c:pt idx="70">
                  <c:v>40940</c:v>
                </c:pt>
                <c:pt idx="71">
                  <c:v>40969</c:v>
                </c:pt>
                <c:pt idx="72">
                  <c:v>41000</c:v>
                </c:pt>
                <c:pt idx="73">
                  <c:v>41030</c:v>
                </c:pt>
                <c:pt idx="74">
                  <c:v>41061</c:v>
                </c:pt>
                <c:pt idx="75">
                  <c:v>41091</c:v>
                </c:pt>
                <c:pt idx="76">
                  <c:v>41122</c:v>
                </c:pt>
                <c:pt idx="77">
                  <c:v>41153</c:v>
                </c:pt>
                <c:pt idx="78">
                  <c:v>41183</c:v>
                </c:pt>
                <c:pt idx="79">
                  <c:v>41214</c:v>
                </c:pt>
                <c:pt idx="80">
                  <c:v>41244</c:v>
                </c:pt>
                <c:pt idx="81">
                  <c:v>41275</c:v>
                </c:pt>
                <c:pt idx="82">
                  <c:v>41306</c:v>
                </c:pt>
                <c:pt idx="83">
                  <c:v>41334</c:v>
                </c:pt>
                <c:pt idx="84">
                  <c:v>41365</c:v>
                </c:pt>
                <c:pt idx="85">
                  <c:v>41395</c:v>
                </c:pt>
                <c:pt idx="86">
                  <c:v>41426</c:v>
                </c:pt>
                <c:pt idx="87">
                  <c:v>41456</c:v>
                </c:pt>
                <c:pt idx="88">
                  <c:v>41487</c:v>
                </c:pt>
                <c:pt idx="89">
                  <c:v>41518</c:v>
                </c:pt>
                <c:pt idx="90">
                  <c:v>41548</c:v>
                </c:pt>
                <c:pt idx="91">
                  <c:v>41579</c:v>
                </c:pt>
                <c:pt idx="92">
                  <c:v>41609</c:v>
                </c:pt>
                <c:pt idx="93">
                  <c:v>41640</c:v>
                </c:pt>
                <c:pt idx="94">
                  <c:v>41671</c:v>
                </c:pt>
                <c:pt idx="95">
                  <c:v>41699</c:v>
                </c:pt>
                <c:pt idx="96">
                  <c:v>41730</c:v>
                </c:pt>
                <c:pt idx="97">
                  <c:v>41760</c:v>
                </c:pt>
                <c:pt idx="98">
                  <c:v>41791</c:v>
                </c:pt>
                <c:pt idx="99">
                  <c:v>41821</c:v>
                </c:pt>
                <c:pt idx="100">
                  <c:v>41852</c:v>
                </c:pt>
                <c:pt idx="101">
                  <c:v>41883</c:v>
                </c:pt>
                <c:pt idx="102">
                  <c:v>41913</c:v>
                </c:pt>
                <c:pt idx="103">
                  <c:v>41944</c:v>
                </c:pt>
                <c:pt idx="104">
                  <c:v>41974</c:v>
                </c:pt>
                <c:pt idx="105">
                  <c:v>42005</c:v>
                </c:pt>
                <c:pt idx="106">
                  <c:v>42036</c:v>
                </c:pt>
                <c:pt idx="107">
                  <c:v>42064</c:v>
                </c:pt>
                <c:pt idx="108">
                  <c:v>42095</c:v>
                </c:pt>
                <c:pt idx="109">
                  <c:v>42125</c:v>
                </c:pt>
                <c:pt idx="110">
                  <c:v>42156</c:v>
                </c:pt>
                <c:pt idx="111">
                  <c:v>42186</c:v>
                </c:pt>
                <c:pt idx="112">
                  <c:v>42217</c:v>
                </c:pt>
                <c:pt idx="113">
                  <c:v>42248</c:v>
                </c:pt>
                <c:pt idx="114">
                  <c:v>42278</c:v>
                </c:pt>
                <c:pt idx="115">
                  <c:v>42309</c:v>
                </c:pt>
                <c:pt idx="116">
                  <c:v>42339</c:v>
                </c:pt>
                <c:pt idx="117">
                  <c:v>42370</c:v>
                </c:pt>
                <c:pt idx="118">
                  <c:v>42401</c:v>
                </c:pt>
                <c:pt idx="119">
                  <c:v>42430</c:v>
                </c:pt>
                <c:pt idx="120">
                  <c:v>42461</c:v>
                </c:pt>
                <c:pt idx="121">
                  <c:v>42491</c:v>
                </c:pt>
                <c:pt idx="122">
                  <c:v>42522</c:v>
                </c:pt>
                <c:pt idx="123">
                  <c:v>42552</c:v>
                </c:pt>
                <c:pt idx="124">
                  <c:v>42583</c:v>
                </c:pt>
                <c:pt idx="125">
                  <c:v>42614</c:v>
                </c:pt>
                <c:pt idx="126">
                  <c:v>42644</c:v>
                </c:pt>
                <c:pt idx="127">
                  <c:v>42675</c:v>
                </c:pt>
                <c:pt idx="128">
                  <c:v>42705</c:v>
                </c:pt>
                <c:pt idx="129">
                  <c:v>42736</c:v>
                </c:pt>
                <c:pt idx="130">
                  <c:v>42767</c:v>
                </c:pt>
                <c:pt idx="131">
                  <c:v>42795</c:v>
                </c:pt>
                <c:pt idx="132">
                  <c:v>42826</c:v>
                </c:pt>
                <c:pt idx="133">
                  <c:v>42856</c:v>
                </c:pt>
                <c:pt idx="134">
                  <c:v>42887</c:v>
                </c:pt>
                <c:pt idx="135">
                  <c:v>42917</c:v>
                </c:pt>
                <c:pt idx="136">
                  <c:v>42948</c:v>
                </c:pt>
                <c:pt idx="137">
                  <c:v>42979</c:v>
                </c:pt>
                <c:pt idx="138">
                  <c:v>43009</c:v>
                </c:pt>
                <c:pt idx="139">
                  <c:v>43040</c:v>
                </c:pt>
                <c:pt idx="140">
                  <c:v>43070</c:v>
                </c:pt>
                <c:pt idx="141">
                  <c:v>43101</c:v>
                </c:pt>
                <c:pt idx="142">
                  <c:v>43132</c:v>
                </c:pt>
                <c:pt idx="143">
                  <c:v>43160</c:v>
                </c:pt>
                <c:pt idx="144">
                  <c:v>43191</c:v>
                </c:pt>
                <c:pt idx="145">
                  <c:v>43221</c:v>
                </c:pt>
                <c:pt idx="146">
                  <c:v>43252</c:v>
                </c:pt>
                <c:pt idx="147">
                  <c:v>43282</c:v>
                </c:pt>
                <c:pt idx="148">
                  <c:v>43313</c:v>
                </c:pt>
                <c:pt idx="149">
                  <c:v>43344</c:v>
                </c:pt>
                <c:pt idx="150">
                  <c:v>43374</c:v>
                </c:pt>
                <c:pt idx="151">
                  <c:v>43405</c:v>
                </c:pt>
                <c:pt idx="152">
                  <c:v>43435</c:v>
                </c:pt>
                <c:pt idx="153">
                  <c:v>43466</c:v>
                </c:pt>
                <c:pt idx="154">
                  <c:v>43497</c:v>
                </c:pt>
                <c:pt idx="155">
                  <c:v>43525</c:v>
                </c:pt>
                <c:pt idx="156">
                  <c:v>43556</c:v>
                </c:pt>
                <c:pt idx="157">
                  <c:v>43586</c:v>
                </c:pt>
                <c:pt idx="158">
                  <c:v>43617</c:v>
                </c:pt>
                <c:pt idx="159">
                  <c:v>43647</c:v>
                </c:pt>
                <c:pt idx="160">
                  <c:v>43678</c:v>
                </c:pt>
                <c:pt idx="161">
                  <c:v>43709</c:v>
                </c:pt>
                <c:pt idx="162">
                  <c:v>43739</c:v>
                </c:pt>
                <c:pt idx="163">
                  <c:v>43770</c:v>
                </c:pt>
                <c:pt idx="164">
                  <c:v>43800</c:v>
                </c:pt>
                <c:pt idx="165">
                  <c:v>43831</c:v>
                </c:pt>
                <c:pt idx="166">
                  <c:v>43862</c:v>
                </c:pt>
                <c:pt idx="167">
                  <c:v>43891</c:v>
                </c:pt>
              </c:numCache>
            </c:numRef>
          </c:cat>
          <c:val>
            <c:numRef>
              <c:f>Sheet1!$G$2:$G$169</c:f>
              <c:numCache>
                <c:formatCode>General</c:formatCode>
                <c:ptCount val="168"/>
                <c:pt idx="0">
                  <c:v>138.37259233460185</c:v>
                </c:pt>
                <c:pt idx="1">
                  <c:v>148.10518277894221</c:v>
                </c:pt>
                <c:pt idx="2">
                  <c:v>144.32555468655389</c:v>
                </c:pt>
                <c:pt idx="3">
                  <c:v>138.80371643957324</c:v>
                </c:pt>
                <c:pt idx="4">
                  <c:v>144.96581889791628</c:v>
                </c:pt>
                <c:pt idx="5">
                  <c:v>134.44961400901465</c:v>
                </c:pt>
                <c:pt idx="6">
                  <c:v>140.97000089838926</c:v>
                </c:pt>
                <c:pt idx="7">
                  <c:v>138.74512033014159</c:v>
                </c:pt>
                <c:pt idx="8">
                  <c:v>136.15500507898224</c:v>
                </c:pt>
                <c:pt idx="9">
                  <c:v>139.37409599775972</c:v>
                </c:pt>
                <c:pt idx="10">
                  <c:v>124.70803719628721</c:v>
                </c:pt>
                <c:pt idx="11">
                  <c:v>140.3401977026511</c:v>
                </c:pt>
                <c:pt idx="12">
                  <c:v>136.85713670469366</c:v>
                </c:pt>
                <c:pt idx="13">
                  <c:v>145.12337177624946</c:v>
                </c:pt>
                <c:pt idx="14">
                  <c:v>142.35411396997591</c:v>
                </c:pt>
                <c:pt idx="15">
                  <c:v>144.54669908882977</c:v>
                </c:pt>
                <c:pt idx="16">
                  <c:v>147.63081843901733</c:v>
                </c:pt>
                <c:pt idx="17">
                  <c:v>132.90081195691911</c:v>
                </c:pt>
                <c:pt idx="18">
                  <c:v>148.08131521660809</c:v>
                </c:pt>
                <c:pt idx="19">
                  <c:v>144.79850661384316</c:v>
                </c:pt>
                <c:pt idx="20">
                  <c:v>141.03456669745341</c:v>
                </c:pt>
                <c:pt idx="21">
                  <c:v>142.32716349315518</c:v>
                </c:pt>
                <c:pt idx="22">
                  <c:v>138.89120396623775</c:v>
                </c:pt>
                <c:pt idx="23">
                  <c:v>139.65972309753604</c:v>
                </c:pt>
                <c:pt idx="24">
                  <c:v>151.475268900298</c:v>
                </c:pt>
                <c:pt idx="25">
                  <c:v>150.4791484019874</c:v>
                </c:pt>
                <c:pt idx="26">
                  <c:v>142.86036074288833</c:v>
                </c:pt>
                <c:pt idx="27">
                  <c:v>149.09562988286683</c:v>
                </c:pt>
                <c:pt idx="28">
                  <c:v>145.42391697633127</c:v>
                </c:pt>
                <c:pt idx="29">
                  <c:v>144.97166442011925</c:v>
                </c:pt>
                <c:pt idx="30">
                  <c:v>154.43891419554913</c:v>
                </c:pt>
                <c:pt idx="31">
                  <c:v>142.0757916048421</c:v>
                </c:pt>
                <c:pt idx="32">
                  <c:v>149.15214354747911</c:v>
                </c:pt>
                <c:pt idx="33">
                  <c:v>141.38250309255528</c:v>
                </c:pt>
                <c:pt idx="34">
                  <c:v>134.71777492985007</c:v>
                </c:pt>
                <c:pt idx="35">
                  <c:v>149.77660438667749</c:v>
                </c:pt>
                <c:pt idx="36">
                  <c:v>149.32287715104843</c:v>
                </c:pt>
                <c:pt idx="37">
                  <c:v>153.55964338117548</c:v>
                </c:pt>
                <c:pt idx="38">
                  <c:v>150.31398773026226</c:v>
                </c:pt>
                <c:pt idx="39">
                  <c:v>159.56515966403296</c:v>
                </c:pt>
                <c:pt idx="40">
                  <c:v>151.96772966102105</c:v>
                </c:pt>
                <c:pt idx="41">
                  <c:v>149.66920761900306</c:v>
                </c:pt>
                <c:pt idx="42">
                  <c:v>155.34520361463763</c:v>
                </c:pt>
                <c:pt idx="43">
                  <c:v>151.62598513094181</c:v>
                </c:pt>
                <c:pt idx="44">
                  <c:v>159.21535045108794</c:v>
                </c:pt>
                <c:pt idx="45">
                  <c:v>154.84716436980651</c:v>
                </c:pt>
                <c:pt idx="46">
                  <c:v>143.580132678919</c:v>
                </c:pt>
                <c:pt idx="47">
                  <c:v>158.58484280722897</c:v>
                </c:pt>
                <c:pt idx="48">
                  <c:v>159.43115389204999</c:v>
                </c:pt>
                <c:pt idx="49">
                  <c:v>155.09411209166103</c:v>
                </c:pt>
                <c:pt idx="50">
                  <c:v>158.50987527710524</c:v>
                </c:pt>
                <c:pt idx="51">
                  <c:v>163.06478753687449</c:v>
                </c:pt>
                <c:pt idx="52">
                  <c:v>158.19237204762521</c:v>
                </c:pt>
                <c:pt idx="53">
                  <c:v>156.70551922490517</c:v>
                </c:pt>
                <c:pt idx="54">
                  <c:v>161.87306087426163</c:v>
                </c:pt>
                <c:pt idx="55">
                  <c:v>161.40863373639604</c:v>
                </c:pt>
                <c:pt idx="56">
                  <c:v>167.32725554285807</c:v>
                </c:pt>
                <c:pt idx="57">
                  <c:v>157.96360011718048</c:v>
                </c:pt>
                <c:pt idx="58">
                  <c:v>152.04376301936878</c:v>
                </c:pt>
                <c:pt idx="59">
                  <c:v>167.8215706795263</c:v>
                </c:pt>
                <c:pt idx="60">
                  <c:v>160.7636351547155</c:v>
                </c:pt>
                <c:pt idx="61">
                  <c:v>165.17496230839657</c:v>
                </c:pt>
                <c:pt idx="62">
                  <c:v>166.98242449734784</c:v>
                </c:pt>
                <c:pt idx="63">
                  <c:v>167.76682409160716</c:v>
                </c:pt>
                <c:pt idx="64">
                  <c:v>171.76240757238452</c:v>
                </c:pt>
                <c:pt idx="65">
                  <c:v>167.61363317207741</c:v>
                </c:pt>
                <c:pt idx="66">
                  <c:v>166.08625956737242</c:v>
                </c:pt>
                <c:pt idx="67">
                  <c:v>172.37354023907491</c:v>
                </c:pt>
                <c:pt idx="68">
                  <c:v>175.2041453926943</c:v>
                </c:pt>
                <c:pt idx="69">
                  <c:v>165.83444275918845</c:v>
                </c:pt>
                <c:pt idx="70">
                  <c:v>166.03058921327295</c:v>
                </c:pt>
                <c:pt idx="71">
                  <c:v>177.1327066203506</c:v>
                </c:pt>
                <c:pt idx="72">
                  <c:v>163.96485520865497</c:v>
                </c:pt>
                <c:pt idx="73">
                  <c:v>184.4758477833158</c:v>
                </c:pt>
                <c:pt idx="74">
                  <c:v>171.94568073863158</c:v>
                </c:pt>
                <c:pt idx="75">
                  <c:v>169.87273976642771</c:v>
                </c:pt>
                <c:pt idx="76">
                  <c:v>180.89578603453455</c:v>
                </c:pt>
                <c:pt idx="77">
                  <c:v>169.04527204055384</c:v>
                </c:pt>
                <c:pt idx="78">
                  <c:v>179.69912051920531</c:v>
                </c:pt>
                <c:pt idx="79">
                  <c:v>183.49170511807</c:v>
                </c:pt>
                <c:pt idx="80">
                  <c:v>176.6405665897461</c:v>
                </c:pt>
                <c:pt idx="81">
                  <c:v>176.3317093290884</c:v>
                </c:pt>
                <c:pt idx="82">
                  <c:v>161.19444270389798</c:v>
                </c:pt>
                <c:pt idx="83">
                  <c:v>182.40536164129173</c:v>
                </c:pt>
                <c:pt idx="84">
                  <c:v>180.44399062011632</c:v>
                </c:pt>
                <c:pt idx="85">
                  <c:v>188.40110169787087</c:v>
                </c:pt>
                <c:pt idx="86">
                  <c:v>175.62096403295592</c:v>
                </c:pt>
                <c:pt idx="87">
                  <c:v>185.24665853394217</c:v>
                </c:pt>
                <c:pt idx="88">
                  <c:v>187.12674648071427</c:v>
                </c:pt>
                <c:pt idx="89">
                  <c:v>175.09790801314719</c:v>
                </c:pt>
                <c:pt idx="90">
                  <c:v>188.23200111008032</c:v>
                </c:pt>
                <c:pt idx="91">
                  <c:v>179.30723531096592</c:v>
                </c:pt>
                <c:pt idx="92">
                  <c:v>186.02579875590033</c:v>
                </c:pt>
                <c:pt idx="93">
                  <c:v>188.59767613506625</c:v>
                </c:pt>
                <c:pt idx="94">
                  <c:v>171.4847661720118</c:v>
                </c:pt>
                <c:pt idx="95">
                  <c:v>185.44486346388206</c:v>
                </c:pt>
                <c:pt idx="96">
                  <c:v>182.99415293481545</c:v>
                </c:pt>
                <c:pt idx="97">
                  <c:v>194.0245729204118</c:v>
                </c:pt>
                <c:pt idx="98">
                  <c:v>181.38690842648543</c:v>
                </c:pt>
                <c:pt idx="99">
                  <c:v>188.95272753233976</c:v>
                </c:pt>
                <c:pt idx="100">
                  <c:v>184.62159952264088</c:v>
                </c:pt>
                <c:pt idx="101">
                  <c:v>173.40254582190659</c:v>
                </c:pt>
                <c:pt idx="102">
                  <c:v>194.97147941000782</c:v>
                </c:pt>
                <c:pt idx="103">
                  <c:v>178.23990247333381</c:v>
                </c:pt>
                <c:pt idx="104">
                  <c:v>189.93636934830712</c:v>
                </c:pt>
                <c:pt idx="105">
                  <c:v>185.77555193174388</c:v>
                </c:pt>
                <c:pt idx="106">
                  <c:v>169.61147423309185</c:v>
                </c:pt>
                <c:pt idx="107">
                  <c:v>192.02655517141193</c:v>
                </c:pt>
                <c:pt idx="108">
                  <c:v>192.57947855890907</c:v>
                </c:pt>
                <c:pt idx="109">
                  <c:v>194.1820212119753</c:v>
                </c:pt>
                <c:pt idx="110">
                  <c:v>190.45556715629911</c:v>
                </c:pt>
                <c:pt idx="111">
                  <c:v>195.36223772024397</c:v>
                </c:pt>
                <c:pt idx="112">
                  <c:v>189.24036295876354</c:v>
                </c:pt>
                <c:pt idx="113">
                  <c:v>186.62546212950735</c:v>
                </c:pt>
                <c:pt idx="114">
                  <c:v>197.35982246437152</c:v>
                </c:pt>
                <c:pt idx="115">
                  <c:v>182.98514566878794</c:v>
                </c:pt>
                <c:pt idx="116">
                  <c:v>195.95563121243177</c:v>
                </c:pt>
                <c:pt idx="117">
                  <c:v>191.76978392878328</c:v>
                </c:pt>
                <c:pt idx="118">
                  <c:v>185.02017986293617</c:v>
                </c:pt>
                <c:pt idx="119">
                  <c:v>196.56486025427549</c:v>
                </c:pt>
                <c:pt idx="120">
                  <c:v>195.18879226566426</c:v>
                </c:pt>
                <c:pt idx="121">
                  <c:v>196.04795712670048</c:v>
                </c:pt>
                <c:pt idx="122">
                  <c:v>204.36406095957184</c:v>
                </c:pt>
                <c:pt idx="123">
                  <c:v>193.82717899038553</c:v>
                </c:pt>
                <c:pt idx="124">
                  <c:v>193.14568800776564</c:v>
                </c:pt>
                <c:pt idx="125">
                  <c:v>197.10580264072431</c:v>
                </c:pt>
                <c:pt idx="126">
                  <c:v>195.7321942309832</c:v>
                </c:pt>
                <c:pt idx="127">
                  <c:v>193.04144622546087</c:v>
                </c:pt>
                <c:pt idx="128">
                  <c:v>195.0922959307768</c:v>
                </c:pt>
                <c:pt idx="129">
                  <c:v>189.18271936197564</c:v>
                </c:pt>
                <c:pt idx="130">
                  <c:v>185.62508789744146</c:v>
                </c:pt>
                <c:pt idx="131">
                  <c:v>201.53949965688332</c:v>
                </c:pt>
                <c:pt idx="132">
                  <c:v>192.15334639283742</c:v>
                </c:pt>
                <c:pt idx="133">
                  <c:v>207.67091566951183</c:v>
                </c:pt>
                <c:pt idx="134">
                  <c:v>206.35046690069734</c:v>
                </c:pt>
                <c:pt idx="135">
                  <c:v>195.37430268612849</c:v>
                </c:pt>
                <c:pt idx="136">
                  <c:v>205.90703021203706</c:v>
                </c:pt>
                <c:pt idx="137">
                  <c:v>201.59530228121363</c:v>
                </c:pt>
                <c:pt idx="138">
                  <c:v>204.89513652636242</c:v>
                </c:pt>
                <c:pt idx="139">
                  <c:v>200.72413444837792</c:v>
                </c:pt>
                <c:pt idx="140">
                  <c:v>200.74686062902185</c:v>
                </c:pt>
                <c:pt idx="141">
                  <c:v>206.61219909296076</c:v>
                </c:pt>
                <c:pt idx="142">
                  <c:v>185.30208815226231</c:v>
                </c:pt>
                <c:pt idx="143">
                  <c:v>210.09035919890607</c:v>
                </c:pt>
                <c:pt idx="144">
                  <c:v>201.98690833222693</c:v>
                </c:pt>
                <c:pt idx="145">
                  <c:v>222.08702704893886</c:v>
                </c:pt>
                <c:pt idx="146">
                  <c:v>214.37719843695407</c:v>
                </c:pt>
                <c:pt idx="147">
                  <c:v>205.12566489799403</c:v>
                </c:pt>
                <c:pt idx="148">
                  <c:v>214.40008472574203</c:v>
                </c:pt>
                <c:pt idx="149">
                  <c:v>197.31843759292158</c:v>
                </c:pt>
                <c:pt idx="150">
                  <c:v>207.62201518185651</c:v>
                </c:pt>
                <c:pt idx="151">
                  <c:v>207.91228301502858</c:v>
                </c:pt>
                <c:pt idx="152">
                  <c:v>204.82417225498412</c:v>
                </c:pt>
                <c:pt idx="153">
                  <c:v>207.41999347090515</c:v>
                </c:pt>
                <c:pt idx="154">
                  <c:v>189.41155501140429</c:v>
                </c:pt>
                <c:pt idx="155">
                  <c:v>212.64830476384532</c:v>
                </c:pt>
                <c:pt idx="156">
                  <c:v>204.7406957218173</c:v>
                </c:pt>
                <c:pt idx="157">
                  <c:v>219.03628622882852</c:v>
                </c:pt>
                <c:pt idx="158">
                  <c:v>203.50648058929082</c:v>
                </c:pt>
                <c:pt idx="159">
                  <c:v>206.80174558119509</c:v>
                </c:pt>
                <c:pt idx="160">
                  <c:v>209.97677619691231</c:v>
                </c:pt>
                <c:pt idx="161">
                  <c:v>199.33527352175221</c:v>
                </c:pt>
                <c:pt idx="162">
                  <c:v>215.12805673456344</c:v>
                </c:pt>
                <c:pt idx="163">
                  <c:v>202.25655494406953</c:v>
                </c:pt>
                <c:pt idx="164">
                  <c:v>206.33111334139008</c:v>
                </c:pt>
                <c:pt idx="165">
                  <c:v>210.8206438887693</c:v>
                </c:pt>
                <c:pt idx="166">
                  <c:v>195.49369116341103</c:v>
                </c:pt>
                <c:pt idx="167">
                  <c:v>202.2367750860731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14-4050-8387-B1BC60353A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38477263"/>
        <c:axId val="138477679"/>
      </c:lineChart>
      <c:dateAx>
        <c:axId val="138477263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Month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[$-409]mmmm\ d\,\ yyyy;@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477679"/>
        <c:crosses val="autoZero"/>
        <c:auto val="1"/>
        <c:lblOffset val="100"/>
        <c:baseTimeUnit val="months"/>
      </c:dateAx>
      <c:valAx>
        <c:axId val="13847767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84772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E547E-6D5C-9ACE-4D91-1B1FDF8487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780832E-CDD4-4F55-BA16-59E7F34F46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1CE60B-9D97-4336-7AAA-3A91B67FC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3059FC-29CF-9204-20A9-9F0F6E76A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33D226-DAF3-4F8A-A978-994411103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038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8A86EE-DB70-AF89-5E65-BFA4850581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C8D279-66D7-84F6-C0FD-E2A9800160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3CDD2-85A4-F69E-5DE1-98D36957B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164688-C364-69D0-0AD4-23CF3C40E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0AA8CD-F554-5B44-FA6A-34DDD8ECE2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41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53AAF8-C744-2B1C-C7F3-C9D423EF00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DD2281-E120-9AD8-6C46-73847F6D8E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8B301-A874-79DD-7F1B-B819FB9E8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246D70-F5D4-03D7-6539-095482298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F606BB-AFB7-7655-F3B2-EC9EDE100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0814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C1141B-B9D0-3C31-6CB8-C553260C74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A6D960-5189-E73F-203E-36FA9F5176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3E9CB6-5894-0055-0CF5-D07954CAC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B2371E-4908-D5F9-FF78-536AF49DC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2DDE6-DFB5-2C0A-32CC-59C2F8F48F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07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5BC82B-86D8-DFDB-56D0-0F1EC12E1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FCF5EA-8DB5-E293-6C5C-F35B62A0BA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6EDA4B-35DD-1A68-3D9C-B5096ACE8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CF6EDA-9A1B-1934-B65D-17479BE46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60BCA0-0F6D-7CFA-2A92-AFEB16AFC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2268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CB633-5397-09D8-5B58-09357E6EA3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84051B-005F-5D0F-20C9-F22ED3D8EC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115C3B-7A45-1619-3F2F-D703A8C309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E8CDCD-65A3-BA19-8E53-798D97BAEC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C66208-C25C-756A-5C55-09CCAF5CA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EFD362-F046-8376-5789-1769E7897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9921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42FA7A-3512-0055-C344-7F5202FDC1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6CADCC-12E5-AA5D-DF7F-2AE22D658E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3C9307-F3AA-AB80-8991-71012F4B08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970D3F-5B0C-FE1C-E841-A99FE46E37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A05B52-99C5-3BCD-D92E-6DAEBD08CC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D1774F-75D1-ABEE-F9B0-2979841D4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7A00FA5-ACA2-E282-250E-A825FF27C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5921A3-D3B1-425E-C12F-F4024FEDE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416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FB70C-1448-C6C7-ADD0-AF4AE7F06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408036-1AF2-6C58-09FD-D02EF10102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90950C-0CC4-EDBA-B6F0-FA4A63A96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39A34C-7905-C61A-C8A8-0D99F5647F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290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71A667-6AD6-A114-5590-8F4E476EE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196620-F4A6-252B-D960-6392915BA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C5487C-BFB8-9DC2-A1A7-66B7AF1B9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9757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BC5B84-BE31-3370-FD09-BB29313D15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5959D8-0D71-65F3-1814-5796F9A112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CBFD7A-F88F-836F-E970-3F289CFD80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8A9DE7-863D-12D2-AA54-4CBE8AEA9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7A5D14-F882-DD40-C610-DCC9B4D18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731A3E-AD89-3F81-91AB-694B8FA09C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549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746E3-5AFB-1EFC-CCBC-FBE7B86B3B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1484FC9-B6FC-A34A-56D4-4D3C107580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AB014B-2174-A57E-56F3-5BE277BC84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9FD099-0AD3-4709-4BB1-CFEF762BC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D09B3A-095E-9445-5D63-0A78BDCA1F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18C817-981A-B6C4-CCBF-18670EFE22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558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33143C-447B-27C4-525F-AB95415DE2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E013B-D5FF-9A89-2989-C282806C80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13848B-FB1C-EABB-83E7-5E1A0EDD99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D12CE7-F678-4A6A-872A-9D737208F22A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876D3C-8917-A155-A576-B2E0CB1991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24CC69-C6AD-5E74-0078-0F0A57B626D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1E0E5-C21E-4ADF-A595-95D4EB4FAC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0421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F403C44-71A6-4682-907C-ED9257C1D3F2}"/>
              </a:ext>
            </a:extLst>
          </p:cNvPr>
          <p:cNvGraphicFramePr>
            <a:graphicFrameLocks/>
          </p:cNvGraphicFramePr>
          <p:nvPr/>
        </p:nvGraphicFramePr>
        <p:xfrm>
          <a:off x="1588756" y="999030"/>
          <a:ext cx="8852704" cy="47592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7B4F9641-69D7-49B2-AA41-9DE315E745BF}"/>
              </a:ext>
            </a:extLst>
          </p:cNvPr>
          <p:cNvCxnSpPr>
            <a:cxnSpLocks/>
          </p:cNvCxnSpPr>
          <p:nvPr/>
        </p:nvCxnSpPr>
        <p:spPr>
          <a:xfrm>
            <a:off x="7103075" y="1404552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967822E4-DC08-49EE-9282-BD42FF8161F1}"/>
              </a:ext>
            </a:extLst>
          </p:cNvPr>
          <p:cNvCxnSpPr>
            <a:cxnSpLocks/>
          </p:cNvCxnSpPr>
          <p:nvPr/>
        </p:nvCxnSpPr>
        <p:spPr>
          <a:xfrm>
            <a:off x="8400535" y="1404552"/>
            <a:ext cx="28833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52C62612-F4ED-A355-D241-C5BFC301604F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7 Figure</a:t>
            </a:r>
          </a:p>
        </p:txBody>
      </p:sp>
    </p:spTree>
    <p:extLst>
      <p:ext uri="{BB962C8B-B14F-4D97-AF65-F5344CB8AC3E}">
        <p14:creationId xmlns:p14="http://schemas.microsoft.com/office/powerpoint/2010/main" val="1947593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8:06Z</dcterms:created>
  <dcterms:modified xsi:type="dcterms:W3CDTF">2023-07-26T15:48:17Z</dcterms:modified>
</cp:coreProperties>
</file>